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10972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D1235-C785-4FCB-BEFB-CA3C962146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822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6342120"/>
            <a:ext cx="822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30854-A8D2-4D19-9070-90A35190D3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63421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63421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E5BD2-5D9F-4F27-94B4-D77F964203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25603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25603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63421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63421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6342120"/>
            <a:ext cx="264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3AA66-FEB4-42B2-A32A-A859405C16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2560320"/>
            <a:ext cx="8229600" cy="7240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A01CC-471D-4DAE-B1A3-536A982AAA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82296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B469D-03CD-489F-B7AB-96C991AC75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40158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2560320"/>
            <a:ext cx="40158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24FA6-4688-4E8D-AC41-A7DB9608FD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A74F6-DDAB-44D4-83D2-90736E50FC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439560"/>
            <a:ext cx="8229600" cy="8478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6BA6D-D1D8-412C-A93A-75C8EAB26D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2560320"/>
            <a:ext cx="40158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63421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47744-6612-46BA-B1FB-D8AEB27B85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40158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63421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C72C7-B8CC-48F7-A193-B91B0868A4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2560320"/>
            <a:ext cx="40158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6342120"/>
            <a:ext cx="8229600" cy="345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81635-3916-4B83-8CC0-040C29305E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439560"/>
            <a:ext cx="82296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2560320"/>
            <a:ext cx="8229600" cy="7240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10169640"/>
            <a:ext cx="2133720" cy="58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10169640"/>
            <a:ext cx="2895840" cy="58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10169640"/>
            <a:ext cx="2133720" cy="58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787BC0-92FD-4E63-B7EC-4D740E556A4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2209680" y="1012680"/>
            <a:ext cx="4648320" cy="5540400"/>
            <a:chOff x="2209680" y="1012680"/>
            <a:chExt cx="4648320" cy="5540400"/>
          </a:xfrm>
        </p:grpSpPr>
        <p:pic>
          <p:nvPicPr>
            <p:cNvPr id="42" name="Chart 7" descr=""/>
            <p:cNvPicPr/>
            <p:nvPr/>
          </p:nvPicPr>
          <p:blipFill>
            <a:blip r:embed="rId1"/>
            <a:stretch/>
          </p:blipFill>
          <p:spPr>
            <a:xfrm>
              <a:off x="2209680" y="1012680"/>
              <a:ext cx="4563000" cy="272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Chart 8" descr=""/>
            <p:cNvPicPr/>
            <p:nvPr/>
          </p:nvPicPr>
          <p:blipFill>
            <a:blip r:embed="rId2"/>
            <a:stretch/>
          </p:blipFill>
          <p:spPr>
            <a:xfrm>
              <a:off x="2282760" y="3834720"/>
              <a:ext cx="4575240" cy="27183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4" name="Chart 9" descr=""/>
          <p:cNvPicPr/>
          <p:nvPr/>
        </p:nvPicPr>
        <p:blipFill>
          <a:blip r:embed="rId3"/>
          <a:stretch/>
        </p:blipFill>
        <p:spPr>
          <a:xfrm>
            <a:off x="2286000" y="6576840"/>
            <a:ext cx="4572000" cy="2719440"/>
          </a:xfrm>
          <a:prstGeom prst="rect">
            <a:avLst/>
          </a:prstGeom>
          <a:ln w="0">
            <a:noFill/>
          </a:ln>
        </p:spPr>
      </p:pic>
      <p:sp>
        <p:nvSpPr>
          <p:cNvPr id="45" name="TextBox 11"/>
          <p:cNvSpPr/>
          <p:nvPr/>
        </p:nvSpPr>
        <p:spPr>
          <a:xfrm>
            <a:off x="3050640" y="795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2"/>
          <p:cNvSpPr/>
          <p:nvPr/>
        </p:nvSpPr>
        <p:spPr>
          <a:xfrm>
            <a:off x="3082320" y="3603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3"/>
          <p:cNvSpPr/>
          <p:nvPr/>
        </p:nvSpPr>
        <p:spPr>
          <a:xfrm>
            <a:off x="3126960" y="6423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feld 1"/>
          <p:cNvSpPr/>
          <p:nvPr/>
        </p:nvSpPr>
        <p:spPr>
          <a:xfrm>
            <a:off x="2514600" y="9524880"/>
            <a:ext cx="44956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g. 1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orrelations between daily feed DM intake and daily eating time in different treatment groups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 = control, B = PBLC lower dose (80 mg/d) and C = PBLC higher dose (160 mg/d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11T07:50:37Z</dcterms:created>
  <dc:creator>Acer</dc:creator>
  <dc:description/>
  <dc:language>en-US</dc:language>
  <cp:lastModifiedBy>Univ.-Prof. Dr. Jörg R. Aschenbach</cp:lastModifiedBy>
  <dcterms:modified xsi:type="dcterms:W3CDTF">2019-09-08T09:55:18Z</dcterms:modified>
  <cp:revision>14</cp:revision>
  <dc:subject/>
  <dc:title>Slide 1</dc:title>
</cp:coreProperties>
</file>